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714CB5-94E0-406D-9263-9E29826F14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D3D9F-4C9D-40BA-973A-74F59D1B5E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500C0-E7D0-42F7-B87B-DA77442CCA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6B2A9D-43B5-415B-BB17-45EA6BCC4D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E7B62-418F-4675-90A7-AE15AFBD62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E151D-5070-40EF-BC70-45C3F22671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EA94F-C565-48D9-A9AF-B88AE41E9B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FED96-E17D-46EB-A184-63C54EADF6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A75410-D75A-419B-8EA8-44EC13E380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1FC47-AD6E-4833-8F1E-BC3E298D8A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DC87BF-07D4-4313-A985-C9A60E3872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AAECF-273B-4148-AAEC-A47B2127FA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17D765-222A-4592-993C-6F15777122E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3"/>
          <p:cNvSpPr/>
          <p:nvPr/>
        </p:nvSpPr>
        <p:spPr>
          <a:xfrm>
            <a:off x="1008000" y="709560"/>
            <a:ext cx="7128000" cy="30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ff"/>
                </a:solidFill>
                <a:latin typeface="Arial"/>
                <a:ea typeface="Times New Roman"/>
              </a:rPr>
              <a:t>MSPILGYWKIKGLVQPTRLLLEYLEEKYEEHLYERDEGDKWRNKKFELGLEFPNLPYYIDGDVKLTQSMAIIRYIADKHNMLGGCPKERAEISMLEGAVLDIRYGVSRIAYSKDFETLKVDFLSKLPEMLKMFEDRLCHKTYLNGDHVTHPDFMLYDALDVVLYMDPMCLDAFPKLVCFKKRIEAIPQIDKYLKSSKYIAWPLQGWQATFGGGDHPPKSDLEVLFQGPLGSPEFPGRLERPHRD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GSLPPSIPPSSALACVLKNLKPLQLSPDLKPKHLIFFCNTIWPQYKLDNCSKWPENGTFDFSTLQDLDNFCHKMGKWSEVPDVQAFFTHHSLPSLCSQCDLSQIFLLSLLSVPSVSSPSSESFESFFSTNPSNLSPPPQAAPHQATPHQAEPGPNSSSASTPLRCNPSITSPPHTQSSLWFHSTTSTPPLAQQFPLREVARAEGIVKINVPFTLSDLSQIS</a:t>
            </a:r>
            <a:r>
              <a:rPr b="0" lang="fr-FR" sz="1200" spc="-1" strike="noStrike">
                <a:solidFill>
                  <a:srgbClr val="c0504d"/>
                </a:solidFill>
                <a:latin typeface="Arial"/>
              </a:rPr>
              <a:t>KLPGKKKKKKRPLEIEGRVDHHHHHHGSI</a:t>
            </a:r>
            <a:r>
              <a:rPr b="0" lang="en-US" sz="1200" spc="-1" strike="noStrike">
                <a:solidFill>
                  <a:srgbClr val="c0504d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22T14:17:54Z</dcterms:created>
  <dc:creator>Christina</dc:creator>
  <dc:description/>
  <dc:language>en-US</dc:language>
  <cp:lastModifiedBy>mullins</cp:lastModifiedBy>
  <dcterms:modified xsi:type="dcterms:W3CDTF">2015-08-05T11:53:01Z</dcterms:modified>
  <cp:revision>2</cp:revision>
  <dc:subject/>
  <dc:title>PowerPoint-Präsentation</dc:title>
</cp:coreProperties>
</file>